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2" r:id="rId2"/>
    <p:sldId id="270" r:id="rId3"/>
    <p:sldId id="268" r:id="rId4"/>
    <p:sldId id="257" r:id="rId5"/>
    <p:sldId id="258" r:id="rId6"/>
    <p:sldId id="262" r:id="rId7"/>
    <p:sldId id="263" r:id="rId8"/>
    <p:sldId id="265" r:id="rId9"/>
  </p:sldIdLst>
  <p:sldSz cx="6858000" cy="9906000" type="A4"/>
  <p:notesSz cx="6811963" cy="99425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42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n Tobias" userId="9e33ea93-47e2-498c-bc01-1138404a0ad4" providerId="ADAL" clId="{C2D01F9A-EA96-4583-9A49-3D97F9C9B6BD}"/>
    <pc:docChg chg="modSld">
      <pc:chgData name="Jon Tobias" userId="9e33ea93-47e2-498c-bc01-1138404a0ad4" providerId="ADAL" clId="{C2D01F9A-EA96-4583-9A49-3D97F9C9B6BD}" dt="2023-09-27T12:11:59.196" v="5" actId="20577"/>
      <pc:docMkLst>
        <pc:docMk/>
      </pc:docMkLst>
      <pc:sldChg chg="modSp mod">
        <pc:chgData name="Jon Tobias" userId="9e33ea93-47e2-498c-bc01-1138404a0ad4" providerId="ADAL" clId="{C2D01F9A-EA96-4583-9A49-3D97F9C9B6BD}" dt="2023-09-27T12:11:59.196" v="5" actId="20577"/>
        <pc:sldMkLst>
          <pc:docMk/>
          <pc:sldMk cId="2785263893" sldId="268"/>
        </pc:sldMkLst>
        <pc:spChg chg="mod">
          <ac:chgData name="Jon Tobias" userId="9e33ea93-47e2-498c-bc01-1138404a0ad4" providerId="ADAL" clId="{C2D01F9A-EA96-4583-9A49-3D97F9C9B6BD}" dt="2023-09-27T12:11:59.196" v="5" actId="20577"/>
          <ac:spMkLst>
            <pc:docMk/>
            <pc:sldMk cId="2785263893" sldId="268"/>
            <ac:spMk id="12" creationId="{818F688A-BA7E-FB63-2D99-FCF6AFCBE13F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C3315-C5A1-4E0B-ABBC-ED3C735184FD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265BE-213D-43E3-B8B6-22F7D69640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2198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C3315-C5A1-4E0B-ABBC-ED3C735184FD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265BE-213D-43E3-B8B6-22F7D69640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2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C3315-C5A1-4E0B-ABBC-ED3C735184FD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265BE-213D-43E3-B8B6-22F7D69640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332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C3315-C5A1-4E0B-ABBC-ED3C735184FD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265BE-213D-43E3-B8B6-22F7D69640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4615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C3315-C5A1-4E0B-ABBC-ED3C735184FD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265BE-213D-43E3-B8B6-22F7D69640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113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C3315-C5A1-4E0B-ABBC-ED3C735184FD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265BE-213D-43E3-B8B6-22F7D69640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2952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C3315-C5A1-4E0B-ABBC-ED3C735184FD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265BE-213D-43E3-B8B6-22F7D69640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427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C3315-C5A1-4E0B-ABBC-ED3C735184FD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265BE-213D-43E3-B8B6-22F7D69640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80738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C3315-C5A1-4E0B-ABBC-ED3C735184FD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265BE-213D-43E3-B8B6-22F7D69640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3947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C3315-C5A1-4E0B-ABBC-ED3C735184FD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265BE-213D-43E3-B8B6-22F7D69640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8440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C3315-C5A1-4E0B-ABBC-ED3C735184FD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265BE-213D-43E3-B8B6-22F7D69640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4063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FC3315-C5A1-4E0B-ABBC-ED3C735184FD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2265BE-213D-43E3-B8B6-22F7D69640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11997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E8E734B-C34A-276D-DED0-ABF2EEC0F760}"/>
              </a:ext>
            </a:extLst>
          </p:cNvPr>
          <p:cNvSpPr txBox="1"/>
          <p:nvPr/>
        </p:nvSpPr>
        <p:spPr>
          <a:xfrm>
            <a:off x="157655" y="682791"/>
            <a:ext cx="63959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Figure S1</a:t>
            </a:r>
            <a:endParaRPr lang="en-GB" sz="12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C84F34F-C35E-7A96-6083-A039A3D7DCE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083" t="24814" r="23750" b="21296"/>
          <a:stretch/>
        </p:blipFill>
        <p:spPr>
          <a:xfrm>
            <a:off x="53615" y="1547585"/>
            <a:ext cx="6604000" cy="36957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F15BF8D-A2D3-051E-1696-EB09C3AE042D}"/>
              </a:ext>
            </a:extLst>
          </p:cNvPr>
          <p:cNvSpPr txBox="1"/>
          <p:nvPr/>
        </p:nvSpPr>
        <p:spPr>
          <a:xfrm>
            <a:off x="157655" y="126760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A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FC99E26-3174-F4AA-8C9B-C575CA6EFEA7}"/>
              </a:ext>
            </a:extLst>
          </p:cNvPr>
          <p:cNvSpPr txBox="1"/>
          <p:nvPr/>
        </p:nvSpPr>
        <p:spPr>
          <a:xfrm>
            <a:off x="3429000" y="135209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B</a:t>
            </a:r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B32F13B-F1EA-5FB6-6F2F-71909CE640C1}"/>
              </a:ext>
            </a:extLst>
          </p:cNvPr>
          <p:cNvSpPr txBox="1"/>
          <p:nvPr/>
        </p:nvSpPr>
        <p:spPr>
          <a:xfrm>
            <a:off x="157655" y="5617029"/>
            <a:ext cx="603994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 </a:t>
            </a:r>
            <a:r>
              <a:rPr lang="en-GB" sz="1200" dirty="0">
                <a:effectLst/>
                <a:ea typeface="Calibri" panose="020F0502020204030204" pitchFamily="34" charset="0"/>
              </a:rPr>
              <a:t>A) </a:t>
            </a:r>
            <a:r>
              <a:rPr lang="en-GB" sz="12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85-point Statistical Shape Model used to o</a:t>
            </a:r>
            <a:r>
              <a:rPr lang="en-GB" sz="1200" b="0" i="0" dirty="0">
                <a:solidFill>
                  <a:srgbClr val="1C1D1E"/>
                </a:solidFill>
                <a:effectLst/>
              </a:rPr>
              <a:t>utline proximal femur shape. Points used to measure femoral neck width (FNW) are shown in white (inferior femoral head points 6-12, superior femoral head points 32-38). </a:t>
            </a:r>
            <a:br>
              <a:rPr lang="en-GB" sz="1200" dirty="0">
                <a:effectLst/>
                <a:ea typeface="Calibri" panose="020F0502020204030204" pitchFamily="34" charset="0"/>
              </a:rPr>
            </a:br>
            <a:r>
              <a:rPr lang="en-GB" sz="1200" dirty="0">
                <a:effectLst/>
                <a:ea typeface="Calibri" panose="020F0502020204030204" pitchFamily="34" charset="0"/>
              </a:rPr>
              <a:t>B) Schematic representation of minimal FNW</a:t>
            </a:r>
            <a:r>
              <a:rPr lang="en-GB" sz="1200" dirty="0">
                <a:ea typeface="Calibri" panose="020F0502020204030204" pitchFamily="34" charset="0"/>
              </a:rPr>
              <a:t> measurement (black line)</a:t>
            </a:r>
            <a:r>
              <a:rPr lang="en-GB" sz="1200" dirty="0">
                <a:effectLst/>
                <a:ea typeface="Calibri" panose="020F0502020204030204" pitchFamily="34" charset="0"/>
              </a:rPr>
              <a:t> derived using line-segment method. </a:t>
            </a:r>
            <a:endParaRPr lang="en-GB" sz="1200" dirty="0">
              <a:solidFill>
                <a:srgbClr val="FF0000"/>
              </a:solidFill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14406B1-A718-5081-BB02-3E9D7B3A4DD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1000" t="27704" r="51166" b="17630"/>
          <a:stretch/>
        </p:blipFill>
        <p:spPr>
          <a:xfrm>
            <a:off x="0" y="1561654"/>
            <a:ext cx="3501571" cy="38685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20065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E9A262B-3522-5D79-D789-CE664EED6986}"/>
              </a:ext>
            </a:extLst>
          </p:cNvPr>
          <p:cNvSpPr txBox="1"/>
          <p:nvPr/>
        </p:nvSpPr>
        <p:spPr>
          <a:xfrm>
            <a:off x="0" y="225881"/>
            <a:ext cx="63959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Figure S2</a:t>
            </a:r>
            <a:endParaRPr lang="en-GB" sz="1200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E7C2A8EC-6E35-BDAA-CD05-57B7346359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52548"/>
            <a:ext cx="6858000" cy="296265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7A1BAD5-30CD-067D-9182-D374E6D77ED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7444" y="4341370"/>
            <a:ext cx="3621031" cy="362103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41AA865-80BE-346C-2523-2C5EDAA1BC89}"/>
              </a:ext>
            </a:extLst>
          </p:cNvPr>
          <p:cNvSpPr txBox="1"/>
          <p:nvPr/>
        </p:nvSpPr>
        <p:spPr>
          <a:xfrm>
            <a:off x="157655" y="95065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A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AB611CC-44FC-4403-23DD-B25BB82ABFCD}"/>
              </a:ext>
            </a:extLst>
          </p:cNvPr>
          <p:cNvSpPr txBox="1"/>
          <p:nvPr/>
        </p:nvSpPr>
        <p:spPr>
          <a:xfrm>
            <a:off x="327811" y="434137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B</a:t>
            </a:r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2BA9E4E-82E0-192E-2DF6-4ED845E74C7C}"/>
              </a:ext>
            </a:extLst>
          </p:cNvPr>
          <p:cNvSpPr txBox="1"/>
          <p:nvPr/>
        </p:nvSpPr>
        <p:spPr>
          <a:xfrm>
            <a:off x="316513" y="8653452"/>
            <a:ext cx="63959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2 </a:t>
            </a:r>
            <a:r>
              <a:rPr lang="en-US" sz="1200" dirty="0"/>
              <a:t>Manhattan plot (A) and QQ-plot (B) of femoral neck width (FNW) GWAS summary statistics</a:t>
            </a:r>
          </a:p>
        </p:txBody>
      </p:sp>
    </p:spTree>
    <p:extLst>
      <p:ext uri="{BB962C8B-B14F-4D97-AF65-F5344CB8AC3E}">
        <p14:creationId xmlns:p14="http://schemas.microsoft.com/office/powerpoint/2010/main" val="14835803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00B518F-ACB6-3726-A061-0D669A8354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0525" y="4263001"/>
            <a:ext cx="3757184" cy="3421858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16F215C-EA87-6A85-2F5F-9F1F52DD22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40838" y="567945"/>
            <a:ext cx="3810532" cy="346377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245FE36-9FEC-AB44-6E87-49BC98276C22}"/>
              </a:ext>
            </a:extLst>
          </p:cNvPr>
          <p:cNvSpPr txBox="1"/>
          <p:nvPr/>
        </p:nvSpPr>
        <p:spPr>
          <a:xfrm>
            <a:off x="43335" y="223381"/>
            <a:ext cx="6247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ure S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18F688A-BA7E-FB63-2D99-FCF6AFCBE13F}"/>
              </a:ext>
            </a:extLst>
          </p:cNvPr>
          <p:cNvSpPr txBox="1"/>
          <p:nvPr/>
        </p:nvSpPr>
        <p:spPr>
          <a:xfrm>
            <a:off x="448527" y="7606744"/>
            <a:ext cx="5842262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3 </a:t>
            </a:r>
          </a:p>
          <a:p>
            <a:r>
              <a:rPr lang="en-US" sz="1200" b="1" dirty="0"/>
              <a:t>(A) </a:t>
            </a:r>
            <a:r>
              <a:rPr lang="en-US" sz="1200" dirty="0"/>
              <a:t>Look-up of conditionally independent FNW genome wide significant signals (p&lt; 5 x 10</a:t>
            </a:r>
            <a:r>
              <a:rPr lang="en-US" sz="1200" baseline="30000" dirty="0"/>
              <a:t>-8</a:t>
            </a:r>
            <a:r>
              <a:rPr lang="en-US" sz="1200" dirty="0"/>
              <a:t>) in a previous FN-BMD GWAS (ref Zheng et. Al). SNPs with a p value &lt; 0.05/60=8.3x10</a:t>
            </a:r>
            <a:r>
              <a:rPr lang="en-US" sz="1200" baseline="30000" dirty="0"/>
              <a:t>-4</a:t>
            </a:r>
            <a:r>
              <a:rPr lang="en-US" sz="1200" dirty="0"/>
              <a:t> in FN-BMD association are highlighted in red (since 60 FNW SNPs were found in the FN-BMD GWAS).</a:t>
            </a:r>
          </a:p>
          <a:p>
            <a:endParaRPr lang="en-US" sz="1200" dirty="0"/>
          </a:p>
          <a:p>
            <a:r>
              <a:rPr lang="en-US" sz="1200" b="1" dirty="0"/>
              <a:t>(B) </a:t>
            </a:r>
            <a:r>
              <a:rPr lang="en-US" sz="1200" dirty="0"/>
              <a:t>Look-up of FN-BMD genome wide significant signals (p&lt; 5 x 10</a:t>
            </a:r>
            <a:r>
              <a:rPr lang="en-US" sz="1200" baseline="30000" dirty="0"/>
              <a:t>-8</a:t>
            </a:r>
            <a:r>
              <a:rPr lang="en-US" sz="1200" dirty="0"/>
              <a:t>; derived from Estrada et al, ref) in the present FNW GWAS. SNPs with a p value &lt; 0.05/47=1.1x10</a:t>
            </a:r>
            <a:r>
              <a:rPr lang="en-US" sz="1200" baseline="30000" dirty="0"/>
              <a:t>-3 </a:t>
            </a:r>
            <a:r>
              <a:rPr lang="en-US" sz="1200" dirty="0"/>
              <a:t>in FNW association are highlighted in red (since 47 FNW SNPs were found in the FNW GWAS).</a:t>
            </a:r>
          </a:p>
          <a:p>
            <a:endParaRPr lang="en-US" sz="1200" dirty="0"/>
          </a:p>
        </p:txBody>
      </p:sp>
      <p:sp>
        <p:nvSpPr>
          <p:cNvPr id="13" name="TextBox 21">
            <a:extLst>
              <a:ext uri="{FF2B5EF4-FFF2-40B4-BE49-F238E27FC236}">
                <a16:creationId xmlns:a16="http://schemas.microsoft.com/office/drawing/2014/main" id="{EC0E0875-126F-3D39-662E-4D01BF6FF9EE}"/>
              </a:ext>
            </a:extLst>
          </p:cNvPr>
          <p:cNvSpPr txBox="1"/>
          <p:nvPr/>
        </p:nvSpPr>
        <p:spPr>
          <a:xfrm>
            <a:off x="1251754" y="26842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A</a:t>
            </a:r>
            <a:endParaRPr lang="en-US" dirty="0"/>
          </a:p>
        </p:txBody>
      </p:sp>
      <p:sp>
        <p:nvSpPr>
          <p:cNvPr id="14" name="TextBox 24">
            <a:extLst>
              <a:ext uri="{FF2B5EF4-FFF2-40B4-BE49-F238E27FC236}">
                <a16:creationId xmlns:a16="http://schemas.microsoft.com/office/drawing/2014/main" id="{44CB1C9E-12B5-42EF-7076-2B7B16938073}"/>
              </a:ext>
            </a:extLst>
          </p:cNvPr>
          <p:cNvSpPr txBox="1"/>
          <p:nvPr/>
        </p:nvSpPr>
        <p:spPr>
          <a:xfrm>
            <a:off x="1274066" y="3991407"/>
            <a:ext cx="273092" cy="379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852638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>
            <a:extLst>
              <a:ext uri="{FF2B5EF4-FFF2-40B4-BE49-F238E27FC236}">
                <a16:creationId xmlns:a16="http://schemas.microsoft.com/office/drawing/2014/main" id="{6E7484CA-CDCB-4201-B96F-BBAE9EC682DD}"/>
              </a:ext>
            </a:extLst>
          </p:cNvPr>
          <p:cNvSpPr txBox="1"/>
          <p:nvPr/>
        </p:nvSpPr>
        <p:spPr>
          <a:xfrm>
            <a:off x="157655" y="111864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A</a:t>
            </a:r>
            <a:endParaRPr lang="en-US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025310B-48BD-41F8-9B60-4CCE2867363B}"/>
              </a:ext>
            </a:extLst>
          </p:cNvPr>
          <p:cNvSpPr txBox="1"/>
          <p:nvPr/>
        </p:nvSpPr>
        <p:spPr>
          <a:xfrm>
            <a:off x="52729" y="4863331"/>
            <a:ext cx="273092" cy="379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/>
              <a:t>B</a:t>
            </a:r>
            <a:endParaRPr lang="en-US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F594840-B9C9-469E-960C-1CA4F7AC8A68}"/>
              </a:ext>
            </a:extLst>
          </p:cNvPr>
          <p:cNvSpPr txBox="1"/>
          <p:nvPr/>
        </p:nvSpPr>
        <p:spPr>
          <a:xfrm>
            <a:off x="69165" y="8624066"/>
            <a:ext cx="644284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Figure S4 </a:t>
            </a:r>
            <a:r>
              <a:rPr lang="en-GB" sz="1200" dirty="0"/>
              <a:t>Mendelian randomization analyses of the causal associations for (A) femoral neck width (FNW, from the present study) and (B) femoral neck bone mineral density (FN-BMD, </a:t>
            </a:r>
            <a:r>
              <a:rPr lang="en-US" sz="1200" dirty="0"/>
              <a:t>PMID: 22504420 and PMID: 26367794</a:t>
            </a:r>
            <a:r>
              <a:rPr lang="en-GB" sz="1200" dirty="0"/>
              <a:t>) using inverse variance weighted (IVW), weighted median and MR-Egger methods. The outcome was risk of hip fracture from a hip fracture GWAS (</a:t>
            </a:r>
            <a:r>
              <a:rPr lang="en-US" sz="1200" b="0" i="0" dirty="0">
                <a:solidFill>
                  <a:srgbClr val="212121"/>
                </a:solidFill>
                <a:effectLst/>
                <a:latin typeface="BlinkMacSystemFont"/>
              </a:rPr>
              <a:t>PMID: 36260985</a:t>
            </a:r>
            <a:r>
              <a:rPr lang="en-GB" sz="1200" dirty="0"/>
              <a:t>).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98E6F5A-A6DC-EFE3-9430-38EBD586E91F}"/>
              </a:ext>
            </a:extLst>
          </p:cNvPr>
          <p:cNvSpPr txBox="1"/>
          <p:nvPr/>
        </p:nvSpPr>
        <p:spPr>
          <a:xfrm>
            <a:off x="69165" y="617766"/>
            <a:ext cx="63959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Figure S4</a:t>
            </a:r>
            <a:endParaRPr lang="en-GB" sz="12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D8C0059-CED9-20DA-BA36-E7A3CA2220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6863" y="1091645"/>
            <a:ext cx="5891082" cy="33647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78DCCD3-4D0D-D26E-2C11-498AC2F2BCF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6863" y="5138697"/>
            <a:ext cx="5963482" cy="32884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84548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545D21E3-F181-4211-9D99-0469764638A1}"/>
              </a:ext>
            </a:extLst>
          </p:cNvPr>
          <p:cNvSpPr txBox="1"/>
          <p:nvPr/>
        </p:nvSpPr>
        <p:spPr>
          <a:xfrm>
            <a:off x="0" y="6645525"/>
            <a:ext cx="644284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Figure S5 </a:t>
            </a:r>
            <a:r>
              <a:rPr lang="en-GB" sz="1200" dirty="0"/>
              <a:t>Mendelian randomization analyses of the causal associations for (A, B) femoral neck width (FNW, from the present study) and (C, D) femoral neck bone mineral density (FN-BMD,</a:t>
            </a:r>
            <a:r>
              <a:rPr lang="en-US" sz="1200" dirty="0"/>
              <a:t> PMID: 22504420 and PMID: 26367794</a:t>
            </a:r>
            <a:r>
              <a:rPr lang="en-GB" sz="1200" dirty="0"/>
              <a:t>) with hip fractures using inverse variance weighted (IVW), weighted median and MR-Egger methods. The outcome was risk of hip fractures in UK-Biobank excluding the subsample used for the FNW GWAS. Analyses for two different SNPs selections are shown, (A, C) SNPs selected using LD-pruning; (B, D) SNPs selected using LD pruning followed by LASSO. 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E7484CA-CDCB-4201-B96F-BBAE9EC682DD}"/>
              </a:ext>
            </a:extLst>
          </p:cNvPr>
          <p:cNvSpPr txBox="1"/>
          <p:nvPr/>
        </p:nvSpPr>
        <p:spPr>
          <a:xfrm>
            <a:off x="157655" y="95065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A</a:t>
            </a:r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61FFF90-6406-4841-A338-7FDF1C1B06EB}"/>
              </a:ext>
            </a:extLst>
          </p:cNvPr>
          <p:cNvSpPr txBox="1"/>
          <p:nvPr/>
        </p:nvSpPr>
        <p:spPr>
          <a:xfrm>
            <a:off x="3220217" y="950651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B</a:t>
            </a:r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8E5A362-8189-4AEF-99B4-52D462A43554}"/>
              </a:ext>
            </a:extLst>
          </p:cNvPr>
          <p:cNvSpPr txBox="1"/>
          <p:nvPr/>
        </p:nvSpPr>
        <p:spPr>
          <a:xfrm>
            <a:off x="3220217" y="3681924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D</a:t>
            </a:r>
            <a:endParaRPr lang="en-US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025310B-48BD-41F8-9B60-4CCE2867363B}"/>
              </a:ext>
            </a:extLst>
          </p:cNvPr>
          <p:cNvSpPr txBox="1"/>
          <p:nvPr/>
        </p:nvSpPr>
        <p:spPr>
          <a:xfrm>
            <a:off x="165671" y="3681924"/>
            <a:ext cx="309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/>
              <a:t>C</a:t>
            </a: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99BF871-6BA8-CC44-BBEF-E81155717890}"/>
              </a:ext>
            </a:extLst>
          </p:cNvPr>
          <p:cNvSpPr txBox="1"/>
          <p:nvPr/>
        </p:nvSpPr>
        <p:spPr>
          <a:xfrm>
            <a:off x="157655" y="281350"/>
            <a:ext cx="63959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Figure S5</a:t>
            </a:r>
            <a:endParaRPr lang="en-GB" sz="12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5054C12-79C3-6C51-8373-A6F743391A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16" y="1248778"/>
            <a:ext cx="2935062" cy="216476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CE4A58B-31D7-AC01-E0E5-45E57C9294F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69479" y="1336790"/>
            <a:ext cx="3878740" cy="208798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38869F65-940B-7EE8-7962-D25EAA13941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407" y="4021066"/>
            <a:ext cx="2940016" cy="212018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F323FDB-6641-229A-15A6-6B3B7B8921C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65930" y="4019726"/>
            <a:ext cx="3804435" cy="21127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393542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545D21E3-F181-4211-9D99-0469764638A1}"/>
              </a:ext>
            </a:extLst>
          </p:cNvPr>
          <p:cNvSpPr txBox="1"/>
          <p:nvPr/>
        </p:nvSpPr>
        <p:spPr>
          <a:xfrm>
            <a:off x="0" y="6645525"/>
            <a:ext cx="644284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Figure S6 </a:t>
            </a:r>
            <a:r>
              <a:rPr lang="en-GB" sz="1200" dirty="0"/>
              <a:t>Mendelian randomization analyses of the causal associations for (A, B) femoral neck width (FNW, from the present study) and (C, D) femoral neck bone mineral density (FN-BMD, </a:t>
            </a:r>
            <a:r>
              <a:rPr lang="en-US" sz="1200" dirty="0"/>
              <a:t>PMID: 22504420 and PMID: 26367794</a:t>
            </a:r>
            <a:r>
              <a:rPr lang="en-GB" sz="1200" dirty="0"/>
              <a:t>) with femoral neck fractures using inverse variance weighted (IVW), weighted median and MR-Egger methods. The outcome was risk of femoral neck fractures in UK-Biobank excluding the subsample used for the FNW GWAS. Analyses for two different SNPs selections are shown, (A, C) SNPs selected using LD-pruning; (B, D) SNPs selected using LD pruning followed by LASSO.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10F8E16-F081-3682-A881-16D8A19EA7B7}"/>
              </a:ext>
            </a:extLst>
          </p:cNvPr>
          <p:cNvSpPr txBox="1"/>
          <p:nvPr/>
        </p:nvSpPr>
        <p:spPr>
          <a:xfrm>
            <a:off x="157655" y="281350"/>
            <a:ext cx="63959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Figure S6</a:t>
            </a:r>
            <a:endParaRPr lang="en-GB" sz="12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E13AEC9-F68C-6BB3-E99B-73D90C42AD1E}"/>
              </a:ext>
            </a:extLst>
          </p:cNvPr>
          <p:cNvSpPr txBox="1"/>
          <p:nvPr/>
        </p:nvSpPr>
        <p:spPr>
          <a:xfrm>
            <a:off x="157655" y="95065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A</a:t>
            </a:r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2CAC42A-DC9D-5B8C-7825-5A584B264640}"/>
              </a:ext>
            </a:extLst>
          </p:cNvPr>
          <p:cNvSpPr txBox="1"/>
          <p:nvPr/>
        </p:nvSpPr>
        <p:spPr>
          <a:xfrm>
            <a:off x="3220217" y="950651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B</a:t>
            </a: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1CA5379-AEC5-E0C1-C13A-1CBE95139169}"/>
              </a:ext>
            </a:extLst>
          </p:cNvPr>
          <p:cNvSpPr txBox="1"/>
          <p:nvPr/>
        </p:nvSpPr>
        <p:spPr>
          <a:xfrm>
            <a:off x="3220217" y="3681924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D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FDAECE1-AF36-4F2D-F5A4-9EAEFEA3E59F}"/>
              </a:ext>
            </a:extLst>
          </p:cNvPr>
          <p:cNvSpPr txBox="1"/>
          <p:nvPr/>
        </p:nvSpPr>
        <p:spPr>
          <a:xfrm>
            <a:off x="165671" y="3681924"/>
            <a:ext cx="309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/>
              <a:t>C</a:t>
            </a:r>
            <a:endParaRPr lang="en-US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DF44C8E1-867B-5265-1AA7-A5FB5C6A94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37" y="1314364"/>
            <a:ext cx="2935062" cy="209541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6A1C9432-D854-9B67-0E8D-17B650E539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41181" y="1330493"/>
            <a:ext cx="3816819" cy="2058259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30508AC5-7144-B7E7-801E-FDF5B0C5EE0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482" y="4050751"/>
            <a:ext cx="2920201" cy="2122657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EEB9643B-4F49-86EF-0ACB-7F527FFE4C6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33689" y="4050414"/>
            <a:ext cx="3824250" cy="21053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304144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545D21E3-F181-4211-9D99-0469764638A1}"/>
              </a:ext>
            </a:extLst>
          </p:cNvPr>
          <p:cNvSpPr txBox="1"/>
          <p:nvPr/>
        </p:nvSpPr>
        <p:spPr>
          <a:xfrm>
            <a:off x="0" y="6645525"/>
            <a:ext cx="644284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Figure S7 </a:t>
            </a:r>
            <a:r>
              <a:rPr lang="en-GB" sz="1200" dirty="0"/>
              <a:t>Mendelian randomization analyses of the causal associations for (A, B) femoral neck width (FNW, from the present study) and (C, D) femoral neck bone mineral density (FN-BMD, </a:t>
            </a:r>
            <a:r>
              <a:rPr lang="en-US" sz="1200" dirty="0"/>
              <a:t>PMID: 22504420 and PMID: 26367794</a:t>
            </a:r>
            <a:r>
              <a:rPr lang="en-GB" sz="1200" dirty="0"/>
              <a:t>) with trochanteric fractures using inverse variance weighted (IVW), weighted median and MR-Egger methods. The outcome was risk of trochanteric fractures in UK-Biobank excluding the subsample used for the FNW GWAS. Analyses for two different SNPs selections are shown, (A, C) SNPs selected using LD-pruning; (B, D) SNPs selected using LD pruning followed by LASSO.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BEBBB7A-E25F-E281-6DD8-B45392DB859A}"/>
              </a:ext>
            </a:extLst>
          </p:cNvPr>
          <p:cNvSpPr txBox="1"/>
          <p:nvPr/>
        </p:nvSpPr>
        <p:spPr>
          <a:xfrm>
            <a:off x="157655" y="281350"/>
            <a:ext cx="63959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Figure S7</a:t>
            </a:r>
            <a:endParaRPr lang="en-GB" sz="12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DA232CA-0691-8301-BD0F-975366DA5DB2}"/>
              </a:ext>
            </a:extLst>
          </p:cNvPr>
          <p:cNvSpPr txBox="1"/>
          <p:nvPr/>
        </p:nvSpPr>
        <p:spPr>
          <a:xfrm>
            <a:off x="157655" y="95065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A</a:t>
            </a:r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8199526-5C38-6FF6-3A14-A5B8FEB03C4F}"/>
              </a:ext>
            </a:extLst>
          </p:cNvPr>
          <p:cNvSpPr txBox="1"/>
          <p:nvPr/>
        </p:nvSpPr>
        <p:spPr>
          <a:xfrm>
            <a:off x="3220217" y="950651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B</a:t>
            </a:r>
            <a:endParaRPr lang="en-US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C6BB11A-5BB9-5FA3-B9C1-26DC0B40150D}"/>
              </a:ext>
            </a:extLst>
          </p:cNvPr>
          <p:cNvSpPr txBox="1"/>
          <p:nvPr/>
        </p:nvSpPr>
        <p:spPr>
          <a:xfrm>
            <a:off x="3220217" y="3681924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D</a:t>
            </a:r>
            <a:endParaRPr lang="en-US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DF9D0E4-A6B3-4F57-AD9A-2FDC70470E6D}"/>
              </a:ext>
            </a:extLst>
          </p:cNvPr>
          <p:cNvSpPr txBox="1"/>
          <p:nvPr/>
        </p:nvSpPr>
        <p:spPr>
          <a:xfrm>
            <a:off x="165671" y="3681924"/>
            <a:ext cx="309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/>
              <a:t>C</a:t>
            </a: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6672DC0-00EC-5CE0-B113-AE260DCBAC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848" y="1209243"/>
            <a:ext cx="2927631" cy="218457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9B25D0A-EA56-97AD-3A34-C25BF27CBD1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25713" y="1206768"/>
            <a:ext cx="3814342" cy="218953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334BDA2-7495-CD86-7D52-B98A759A4DD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399" y="3989320"/>
            <a:ext cx="2935062" cy="219696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A678803-D264-0EC5-5843-6351D655060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25720" y="3981743"/>
            <a:ext cx="3829203" cy="21920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717896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545D21E3-F181-4211-9D99-0469764638A1}"/>
              </a:ext>
            </a:extLst>
          </p:cNvPr>
          <p:cNvSpPr txBox="1"/>
          <p:nvPr/>
        </p:nvSpPr>
        <p:spPr>
          <a:xfrm>
            <a:off x="0" y="7046966"/>
            <a:ext cx="644284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Figure S8 </a:t>
            </a:r>
            <a:r>
              <a:rPr lang="en-GB" sz="1200" dirty="0"/>
              <a:t>Mendelian randomization analyses of the causal associations for (A, B) femoral neck width (FNW, from the present study) and (C, D) femoral neck bone mineral density (FN-BMD, </a:t>
            </a:r>
            <a:r>
              <a:rPr lang="en-US" sz="1200" dirty="0"/>
              <a:t>PMID: 22504420 and PMID: 26367794</a:t>
            </a:r>
            <a:r>
              <a:rPr lang="en-GB" sz="1200" dirty="0"/>
              <a:t>) with forearm fractures using inverse variance weighted (IVW), weighted median and MR-Egger methods. The outcome was risk of forearm fractures in UK-Biobank excluding the subsample used for the FNW GWAS. Analyses for two different SNPs selections are shown, (A, C) SNPs selected using LD-pruning; (B, D) SNPs selected using LD pruning followed by LASSO. 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E7484CA-CDCB-4201-B96F-BBAE9EC682DD}"/>
              </a:ext>
            </a:extLst>
          </p:cNvPr>
          <p:cNvSpPr txBox="1"/>
          <p:nvPr/>
        </p:nvSpPr>
        <p:spPr>
          <a:xfrm>
            <a:off x="157655" y="135209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A</a:t>
            </a:r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61FFF90-6406-4841-A338-7FDF1C1B06EB}"/>
              </a:ext>
            </a:extLst>
          </p:cNvPr>
          <p:cNvSpPr txBox="1"/>
          <p:nvPr/>
        </p:nvSpPr>
        <p:spPr>
          <a:xfrm>
            <a:off x="3220217" y="135209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B</a:t>
            </a:r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8E5A362-8189-4AEF-99B4-52D462A43554}"/>
              </a:ext>
            </a:extLst>
          </p:cNvPr>
          <p:cNvSpPr txBox="1"/>
          <p:nvPr/>
        </p:nvSpPr>
        <p:spPr>
          <a:xfrm>
            <a:off x="3220217" y="4083365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D</a:t>
            </a:r>
            <a:endParaRPr lang="en-US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025310B-48BD-41F8-9B60-4CCE2867363B}"/>
              </a:ext>
            </a:extLst>
          </p:cNvPr>
          <p:cNvSpPr txBox="1"/>
          <p:nvPr/>
        </p:nvSpPr>
        <p:spPr>
          <a:xfrm>
            <a:off x="165671" y="4083365"/>
            <a:ext cx="309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/>
              <a:t>C</a:t>
            </a: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CC71D5F-32EE-602E-43C8-F421559170CB}"/>
              </a:ext>
            </a:extLst>
          </p:cNvPr>
          <p:cNvSpPr txBox="1"/>
          <p:nvPr/>
        </p:nvSpPr>
        <p:spPr>
          <a:xfrm>
            <a:off x="157655" y="682791"/>
            <a:ext cx="63959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Figure S8</a:t>
            </a:r>
            <a:endParaRPr lang="en-GB" sz="12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5244303-EF8B-7CCF-E50D-4476584045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490" y="1647483"/>
            <a:ext cx="2949923" cy="216724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8C9537F-81DF-41E5-EC8B-07A7C928641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20192" y="1657773"/>
            <a:ext cx="3816819" cy="215733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2F6D3A9-3946-F6E6-EBDA-5B6DE957A4C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124" y="4391310"/>
            <a:ext cx="2942493" cy="2137518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F26D939D-F96D-A39C-00ED-ECD1D19FCD6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19194" y="4401218"/>
            <a:ext cx="3804435" cy="21276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34225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354</TotalTime>
  <Words>774</Words>
  <Application>Microsoft Office PowerPoint</Application>
  <PresentationFormat>A4 Paper (210x297 mm)</PresentationFormat>
  <Paragraphs>43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BlinkMacSystemFont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Nethander</dc:creator>
  <cp:lastModifiedBy>Jon Tobias</cp:lastModifiedBy>
  <cp:revision>100</cp:revision>
  <cp:lastPrinted>2023-03-27T15:31:43Z</cp:lastPrinted>
  <dcterms:created xsi:type="dcterms:W3CDTF">2022-12-07T09:34:13Z</dcterms:created>
  <dcterms:modified xsi:type="dcterms:W3CDTF">2023-09-27T12:12:02Z</dcterms:modified>
</cp:coreProperties>
</file>